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2" r:id="rId2"/>
    <p:sldId id="269" r:id="rId3"/>
    <p:sldId id="265" r:id="rId4"/>
    <p:sldId id="266" r:id="rId5"/>
    <p:sldId id="267" r:id="rId6"/>
    <p:sldId id="271" r:id="rId7"/>
    <p:sldId id="268" r:id="rId8"/>
  </p:sldIdLst>
  <p:sldSz cx="9906000" cy="6858000" type="A4"/>
  <p:notesSz cx="6797675" cy="9926638"/>
  <p:defaultTextStyle>
    <a:defPPr>
      <a:defRPr lang="ko-KR"/>
    </a:defPPr>
    <a:lvl1pPr marL="0" algn="l" defTabSz="957925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78963" algn="l" defTabSz="957925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57925" algn="l" defTabSz="957925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36888" algn="l" defTabSz="957925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15851" algn="l" defTabSz="957925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394814" algn="l" defTabSz="957925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873776" algn="l" defTabSz="957925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352739" algn="l" defTabSz="957925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831702" algn="l" defTabSz="957925" rtl="0" eaLnBrk="1" latinLnBrk="1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010" autoAdjust="0"/>
  </p:normalViewPr>
  <p:slideViewPr>
    <p:cSldViewPr>
      <p:cViewPr>
        <p:scale>
          <a:sx n="100" d="100"/>
          <a:sy n="100" d="100"/>
        </p:scale>
        <p:origin x="-480" y="-108"/>
      </p:cViewPr>
      <p:guideLst>
        <p:guide orient="horz" pos="3133"/>
        <p:guide orient="horz" pos="213"/>
        <p:guide orient="horz" pos="482"/>
        <p:guide orient="horz" pos="2478"/>
        <p:guide pos="3120"/>
        <p:guide pos="39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D42A37-10FD-459B-B77D-09371CE16A6C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711200" y="744538"/>
            <a:ext cx="537527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525214-BB4C-4D15-B380-F3B65CF2EC2E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90978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12872" rtl="0" eaLnBrk="1" latinLnBrk="1" hangingPunct="1">
      <a:defRPr sz="300" kern="1200">
        <a:solidFill>
          <a:schemeClr val="tx1"/>
        </a:solidFill>
        <a:latin typeface="+mn-lt"/>
        <a:ea typeface="+mn-ea"/>
        <a:cs typeface="+mn-cs"/>
      </a:defRPr>
    </a:lvl1pPr>
    <a:lvl2pPr marL="106436" algn="l" defTabSz="212872" rtl="0" eaLnBrk="1" latinLnBrk="1" hangingPunct="1">
      <a:defRPr sz="300" kern="1200">
        <a:solidFill>
          <a:schemeClr val="tx1"/>
        </a:solidFill>
        <a:latin typeface="+mn-lt"/>
        <a:ea typeface="+mn-ea"/>
        <a:cs typeface="+mn-cs"/>
      </a:defRPr>
    </a:lvl2pPr>
    <a:lvl3pPr marL="212872" algn="l" defTabSz="212872" rtl="0" eaLnBrk="1" latinLnBrk="1" hangingPunct="1">
      <a:defRPr sz="300" kern="1200">
        <a:solidFill>
          <a:schemeClr val="tx1"/>
        </a:solidFill>
        <a:latin typeface="+mn-lt"/>
        <a:ea typeface="+mn-ea"/>
        <a:cs typeface="+mn-cs"/>
      </a:defRPr>
    </a:lvl3pPr>
    <a:lvl4pPr marL="319308" algn="l" defTabSz="212872" rtl="0" eaLnBrk="1" latinLnBrk="1" hangingPunct="1">
      <a:defRPr sz="300" kern="1200">
        <a:solidFill>
          <a:schemeClr val="tx1"/>
        </a:solidFill>
        <a:latin typeface="+mn-lt"/>
        <a:ea typeface="+mn-ea"/>
        <a:cs typeface="+mn-cs"/>
      </a:defRPr>
    </a:lvl4pPr>
    <a:lvl5pPr marL="425745" algn="l" defTabSz="212872" rtl="0" eaLnBrk="1" latinLnBrk="1" hangingPunct="1">
      <a:defRPr sz="300" kern="1200">
        <a:solidFill>
          <a:schemeClr val="tx1"/>
        </a:solidFill>
        <a:latin typeface="+mn-lt"/>
        <a:ea typeface="+mn-ea"/>
        <a:cs typeface="+mn-cs"/>
      </a:defRPr>
    </a:lvl5pPr>
    <a:lvl6pPr marL="532181" algn="l" defTabSz="212872" rtl="0" eaLnBrk="1" latinLnBrk="1" hangingPunct="1">
      <a:defRPr sz="300" kern="1200">
        <a:solidFill>
          <a:schemeClr val="tx1"/>
        </a:solidFill>
        <a:latin typeface="+mn-lt"/>
        <a:ea typeface="+mn-ea"/>
        <a:cs typeface="+mn-cs"/>
      </a:defRPr>
    </a:lvl6pPr>
    <a:lvl7pPr marL="638617" algn="l" defTabSz="212872" rtl="0" eaLnBrk="1" latinLnBrk="1" hangingPunct="1">
      <a:defRPr sz="300" kern="1200">
        <a:solidFill>
          <a:schemeClr val="tx1"/>
        </a:solidFill>
        <a:latin typeface="+mn-lt"/>
        <a:ea typeface="+mn-ea"/>
        <a:cs typeface="+mn-cs"/>
      </a:defRPr>
    </a:lvl7pPr>
    <a:lvl8pPr marL="745053" algn="l" defTabSz="212872" rtl="0" eaLnBrk="1" latinLnBrk="1" hangingPunct="1">
      <a:defRPr sz="300" kern="1200">
        <a:solidFill>
          <a:schemeClr val="tx1"/>
        </a:solidFill>
        <a:latin typeface="+mn-lt"/>
        <a:ea typeface="+mn-ea"/>
        <a:cs typeface="+mn-cs"/>
      </a:defRPr>
    </a:lvl8pPr>
    <a:lvl9pPr marL="851489" algn="l" defTabSz="212872" rtl="0" eaLnBrk="1" latinLnBrk="1" hangingPunct="1">
      <a:defRPr sz="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789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579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368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158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3948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737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527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317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22623862" y="1730375"/>
            <a:ext cx="7020189" cy="368649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1559852" y="1730375"/>
            <a:ext cx="20898908" cy="368649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2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82506" y="2906714"/>
            <a:ext cx="8420100" cy="150018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78963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5792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3pPr>
            <a:lvl4pPr marL="1436888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1585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39481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87377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352739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831702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1559853" y="10080625"/>
            <a:ext cx="13959549" cy="2851467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15684500" y="10080625"/>
            <a:ext cx="13959550" cy="2851467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963" indent="0">
              <a:buNone/>
              <a:defRPr sz="2100" b="1"/>
            </a:lvl2pPr>
            <a:lvl3pPr marL="957925" indent="0">
              <a:buNone/>
              <a:defRPr sz="1900" b="1"/>
            </a:lvl3pPr>
            <a:lvl4pPr marL="1436888" indent="0">
              <a:buNone/>
              <a:defRPr sz="1700" b="1"/>
            </a:lvl4pPr>
            <a:lvl5pPr marL="1915851" indent="0">
              <a:buNone/>
              <a:defRPr sz="1700" b="1"/>
            </a:lvl5pPr>
            <a:lvl6pPr marL="2394814" indent="0">
              <a:buNone/>
              <a:defRPr sz="1700" b="1"/>
            </a:lvl6pPr>
            <a:lvl7pPr marL="2873776" indent="0">
              <a:buNone/>
              <a:defRPr sz="1700" b="1"/>
            </a:lvl7pPr>
            <a:lvl8pPr marL="3352739" indent="0">
              <a:buNone/>
              <a:defRPr sz="1700" b="1"/>
            </a:lvl8pPr>
            <a:lvl9pPr marL="3831702" indent="0">
              <a:buNone/>
              <a:defRPr sz="17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89" cy="639762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963" indent="0">
              <a:buNone/>
              <a:defRPr sz="2100" b="1"/>
            </a:lvl2pPr>
            <a:lvl3pPr marL="957925" indent="0">
              <a:buNone/>
              <a:defRPr sz="1900" b="1"/>
            </a:lvl3pPr>
            <a:lvl4pPr marL="1436888" indent="0">
              <a:buNone/>
              <a:defRPr sz="1700" b="1"/>
            </a:lvl4pPr>
            <a:lvl5pPr marL="1915851" indent="0">
              <a:buNone/>
              <a:defRPr sz="1700" b="1"/>
            </a:lvl5pPr>
            <a:lvl6pPr marL="2394814" indent="0">
              <a:buNone/>
              <a:defRPr sz="1700" b="1"/>
            </a:lvl6pPr>
            <a:lvl7pPr marL="2873776" indent="0">
              <a:buNone/>
              <a:defRPr sz="1700" b="1"/>
            </a:lvl7pPr>
            <a:lvl8pPr marL="3352739" indent="0">
              <a:buNone/>
              <a:defRPr sz="1700" b="1"/>
            </a:lvl8pPr>
            <a:lvl9pPr marL="3831702" indent="0">
              <a:buNone/>
              <a:defRPr sz="17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89" cy="3951288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95301" y="273051"/>
            <a:ext cx="3259006" cy="1162050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30" cy="5853113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5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95301" y="1435101"/>
            <a:ext cx="3259006" cy="4691063"/>
          </a:xfrm>
        </p:spPr>
        <p:txBody>
          <a:bodyPr/>
          <a:lstStyle>
            <a:lvl1pPr marL="0" indent="0">
              <a:buNone/>
              <a:defRPr sz="1500"/>
            </a:lvl1pPr>
            <a:lvl2pPr marL="478963" indent="0">
              <a:buNone/>
              <a:defRPr sz="1300"/>
            </a:lvl2pPr>
            <a:lvl3pPr marL="957925" indent="0">
              <a:buNone/>
              <a:defRPr sz="1000"/>
            </a:lvl3pPr>
            <a:lvl4pPr marL="1436888" indent="0">
              <a:buNone/>
              <a:defRPr sz="1000"/>
            </a:lvl4pPr>
            <a:lvl5pPr marL="1915851" indent="0">
              <a:buNone/>
              <a:defRPr sz="1000"/>
            </a:lvl5pPr>
            <a:lvl6pPr marL="2394814" indent="0">
              <a:buNone/>
              <a:defRPr sz="1000"/>
            </a:lvl6pPr>
            <a:lvl7pPr marL="2873776" indent="0">
              <a:buNone/>
              <a:defRPr sz="1000"/>
            </a:lvl7pPr>
            <a:lvl8pPr marL="3352739" indent="0">
              <a:buNone/>
              <a:defRPr sz="1000"/>
            </a:lvl8pPr>
            <a:lvl9pPr marL="3831702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400"/>
            </a:lvl1pPr>
            <a:lvl2pPr marL="478963" indent="0">
              <a:buNone/>
              <a:defRPr sz="2900"/>
            </a:lvl2pPr>
            <a:lvl3pPr marL="957925" indent="0">
              <a:buNone/>
              <a:defRPr sz="2500"/>
            </a:lvl3pPr>
            <a:lvl4pPr marL="1436888" indent="0">
              <a:buNone/>
              <a:defRPr sz="2100"/>
            </a:lvl4pPr>
            <a:lvl5pPr marL="1915851" indent="0">
              <a:buNone/>
              <a:defRPr sz="2100"/>
            </a:lvl5pPr>
            <a:lvl6pPr marL="2394814" indent="0">
              <a:buNone/>
              <a:defRPr sz="2100"/>
            </a:lvl6pPr>
            <a:lvl7pPr marL="2873776" indent="0">
              <a:buNone/>
              <a:defRPr sz="2100"/>
            </a:lvl7pPr>
            <a:lvl8pPr marL="3352739" indent="0">
              <a:buNone/>
              <a:defRPr sz="2100"/>
            </a:lvl8pPr>
            <a:lvl9pPr marL="3831702" indent="0">
              <a:buNone/>
              <a:defRPr sz="21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500"/>
            </a:lvl1pPr>
            <a:lvl2pPr marL="478963" indent="0">
              <a:buNone/>
              <a:defRPr sz="1300"/>
            </a:lvl2pPr>
            <a:lvl3pPr marL="957925" indent="0">
              <a:buNone/>
              <a:defRPr sz="1000"/>
            </a:lvl3pPr>
            <a:lvl4pPr marL="1436888" indent="0">
              <a:buNone/>
              <a:defRPr sz="1000"/>
            </a:lvl4pPr>
            <a:lvl5pPr marL="1915851" indent="0">
              <a:buNone/>
              <a:defRPr sz="1000"/>
            </a:lvl5pPr>
            <a:lvl6pPr marL="2394814" indent="0">
              <a:buNone/>
              <a:defRPr sz="1000"/>
            </a:lvl6pPr>
            <a:lvl7pPr marL="2873776" indent="0">
              <a:buNone/>
              <a:defRPr sz="1000"/>
            </a:lvl7pPr>
            <a:lvl8pPr marL="3352739" indent="0">
              <a:buNone/>
              <a:defRPr sz="1000"/>
            </a:lvl8pPr>
            <a:lvl9pPr marL="3831702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5793" tIns="47896" rIns="95793" bIns="47896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5793" tIns="47896" rIns="95793" bIns="47896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5793" tIns="47896" rIns="95793" bIns="47896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CAC978-C2CD-4488-9BD6-1D5978D1F250}" type="datetimeFigureOut">
              <a:rPr lang="ko-KR" altLang="en-US" smtClean="0"/>
              <a:pPr/>
              <a:t>2015-01-2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5793" tIns="47896" rIns="95793" bIns="47896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5793" tIns="47896" rIns="95793" bIns="47896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BA9685-36C4-4C3C-9F9F-6CB25DDC35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57925" rtl="0" eaLnBrk="1" latinLnBrk="1" hangingPunct="1">
        <a:spcBef>
          <a:spcPct val="0"/>
        </a:spcBef>
        <a:buNone/>
        <a:defRPr sz="46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222" indent="-359222" algn="l" defTabSz="957925" rtl="0" eaLnBrk="1" latinLnBrk="1" hangingPunct="1">
        <a:spcBef>
          <a:spcPct val="20000"/>
        </a:spcBef>
        <a:buFont typeface="Arial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1pPr>
      <a:lvl2pPr marL="778314" indent="-299352" algn="l" defTabSz="957925" rtl="0" eaLnBrk="1" latinLnBrk="1" hangingPunct="1">
        <a:spcBef>
          <a:spcPct val="20000"/>
        </a:spcBef>
        <a:buFont typeface="Arial" pitchFamily="34" charset="0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197407" indent="-239481" algn="l" defTabSz="957925" rtl="0" eaLnBrk="1" latinLnBrk="1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676370" indent="-239481" algn="l" defTabSz="957925" rtl="0" eaLnBrk="1" latinLnBrk="1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55332" indent="-239481" algn="l" defTabSz="957925" rtl="0" eaLnBrk="1" latinLnBrk="1" hangingPunct="1">
        <a:spcBef>
          <a:spcPct val="20000"/>
        </a:spcBef>
        <a:buFont typeface="Arial" pitchFamily="34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34295" indent="-239481" algn="l" defTabSz="957925" rtl="0" eaLnBrk="1" latinLnBrk="1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13258" indent="-239481" algn="l" defTabSz="957925" rtl="0" eaLnBrk="1" latinLnBrk="1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592220" indent="-239481" algn="l" defTabSz="957925" rtl="0" eaLnBrk="1" latinLnBrk="1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071183" indent="-239481" algn="l" defTabSz="957925" rtl="0" eaLnBrk="1" latinLnBrk="1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57925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78963" algn="l" defTabSz="957925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57925" algn="l" defTabSz="957925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36888" algn="l" defTabSz="957925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15851" algn="l" defTabSz="957925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94814" algn="l" defTabSz="957925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73776" algn="l" defTabSz="957925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352739" algn="l" defTabSz="957925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31702" algn="l" defTabSz="957925" rtl="0" eaLnBrk="1" latinLnBrk="1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9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1679" y="1007198"/>
            <a:ext cx="8349793" cy="18225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580935" y="726345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A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62118" y="4512"/>
            <a:ext cx="9399394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2 Figure. </a:t>
            </a:r>
            <a:r>
              <a:rPr lang="en-US" altLang="ko-KR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S spectra matched to different sequences between </a:t>
            </a:r>
            <a:r>
              <a:rPr lang="en-US" altLang="ko-KR" sz="14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r>
              <a:rPr lang="en-US" altLang="ko-KR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and HFDB searches of Calu-1 </a:t>
            </a:r>
            <a:r>
              <a:rPr lang="en-US" altLang="ko-KR" sz="14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ecretome</a:t>
            </a:r>
            <a:r>
              <a:rPr lang="en-US" altLang="ko-KR" sz="14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. </a:t>
            </a:r>
            <a:endParaRPr lang="en-US" altLang="ko-KR" sz="14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2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52431" y="2996952"/>
            <a:ext cx="5617607" cy="37621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188974" y="431704"/>
            <a:ext cx="8012497" cy="57549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dentical 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pectra were matched to different peptides depending on the database used. In all such cases, PSM 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cores represented by –log PEP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, which calculated by the ratio of hits from decoy and true database search with a given 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core, 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became bigger when HFDB was used instead of </a:t>
            </a:r>
            <a:r>
              <a:rPr lang="en-US" altLang="ko-KR" sz="12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3723377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544" y="379897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B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162119" y="4512"/>
            <a:ext cx="5622974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2 Figure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346250" y="469300"/>
            <a:ext cx="5622974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EcDTDGWTNDIPIcEVVK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matched in </a:t>
            </a:r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352600" y="3645024"/>
            <a:ext cx="5622974" cy="390828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EcDTNGWTNDIPIcEVVK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matched in 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FDB</a:t>
            </a:r>
            <a:endParaRPr lang="en-US" altLang="ko-KR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604" y="668386"/>
            <a:ext cx="9000000" cy="28951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412" y="3831432"/>
            <a:ext cx="9000000" cy="28951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33915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544" y="379897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B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346250" y="469300"/>
            <a:ext cx="6415062" cy="390828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LANVNIGSLIcNVGAGGPAPAAGAAPAGGPAPSTAAAPAEEK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matched in </a:t>
            </a:r>
            <a:r>
              <a:rPr lang="en-US" altLang="ko-KR" sz="12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endParaRPr lang="en-US" altLang="ko-KR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352600" y="3645024"/>
            <a:ext cx="5622974" cy="390828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ISSLEVIGAGLHcPSPQLIATLK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matched in HFDB</a:t>
            </a:r>
          </a:p>
          <a:p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041" y="3817615"/>
            <a:ext cx="9000000" cy="28951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5041" y="649263"/>
            <a:ext cx="9000000" cy="28951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62119" y="4512"/>
            <a:ext cx="5622974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2 Figure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31421050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544" y="379897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B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346250" y="469300"/>
            <a:ext cx="5766990" cy="20616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TEVPVSWESFNNGDcFILDLGNNIHQWcGSNSNR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matched in </a:t>
            </a:r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352600" y="3645024"/>
            <a:ext cx="5622974" cy="390828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TEVPVSWESFNNGDcFILDLGNDIYQWcGSSSNR</a:t>
            </a:r>
            <a:r>
              <a:rPr lang="en-US" altLang="ko-KR" sz="12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matched 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in HFDB</a:t>
            </a:r>
          </a:p>
          <a:p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411" y="658788"/>
            <a:ext cx="9000000" cy="28951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733" y="3827140"/>
            <a:ext cx="9000000" cy="28951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62119" y="4512"/>
            <a:ext cx="5622974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2 Figure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933915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544" y="379897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B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346250" y="469300"/>
            <a:ext cx="5622974" cy="390828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LVLIAFAQYLQQcPFEDHVK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matched in </a:t>
            </a:r>
            <a:r>
              <a:rPr lang="en-US" altLang="ko-KR" sz="12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endParaRPr lang="en-US" altLang="ko-KR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352600" y="3645024"/>
            <a:ext cx="5622974" cy="390828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GLVLIAFSQYLQQcPFDEHVK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matched in HFDB</a:t>
            </a:r>
          </a:p>
          <a:p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003" y="3841661"/>
            <a:ext cx="9000000" cy="28951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227" y="668326"/>
            <a:ext cx="9000000" cy="28951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62119" y="4512"/>
            <a:ext cx="5622974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2 Figure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933915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544" y="379897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B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346250" y="469300"/>
            <a:ext cx="5622974" cy="390828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ALVLIAFAQYLQQcPFEDHVK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matched in </a:t>
            </a:r>
            <a:r>
              <a:rPr lang="en-US" altLang="ko-KR" sz="12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endParaRPr lang="en-US" altLang="ko-KR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352600" y="3645024"/>
            <a:ext cx="5622974" cy="390828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GLVLIAFSQYLQQcPFDEHVK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matched in HFDB</a:t>
            </a:r>
          </a:p>
          <a:p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5122" name="Picture 2"/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874" y="659566"/>
            <a:ext cx="9000000" cy="2894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3" name="Picture 3"/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0055" y="3832473"/>
            <a:ext cx="9000000" cy="2894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62119" y="4512"/>
            <a:ext cx="5622974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2 Figure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40104906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TextBox 22"/>
          <p:cNvSpPr txBox="1"/>
          <p:nvPr/>
        </p:nvSpPr>
        <p:spPr>
          <a:xfrm>
            <a:off x="848544" y="379897"/>
            <a:ext cx="416046" cy="329272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20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B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346250" y="469300"/>
            <a:ext cx="5622974" cy="390828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cGPIDLLFVLDSSESIGLQNFEIAK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matched in </a:t>
            </a:r>
            <a:r>
              <a:rPr lang="en-US" altLang="ko-KR" sz="1200" dirty="0" err="1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HuDB</a:t>
            </a:r>
            <a:endParaRPr lang="en-US" altLang="ko-KR" sz="12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  <a:p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352600" y="3645024"/>
            <a:ext cx="5622974" cy="390828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sz="12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cGPIDLFVLDSSESIGLQNFEIAK</a:t>
            </a:r>
            <a:r>
              <a:rPr lang="en-US" altLang="ko-KR" sz="12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matched in HFDB</a:t>
            </a:r>
          </a:p>
          <a:p>
            <a:endParaRPr lang="en-US" altLang="ko-KR" sz="1200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7745" y="656412"/>
            <a:ext cx="9001000" cy="289542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6604" y="3830970"/>
            <a:ext cx="9000000" cy="289510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62119" y="4512"/>
            <a:ext cx="5622974" cy="313884"/>
          </a:xfrm>
          <a:prstGeom prst="rect">
            <a:avLst/>
          </a:prstGeom>
          <a:noFill/>
        </p:spPr>
        <p:txBody>
          <a:bodyPr wrap="square" lIns="21287" tIns="10644" rIns="21287" bIns="10644" rtlCol="0">
            <a:spAutoFit/>
          </a:bodyPr>
          <a:lstStyle/>
          <a:p>
            <a:r>
              <a:rPr lang="en-US" altLang="ko-KR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2 Figure</a:t>
            </a:r>
            <a:endParaRPr lang="en-US" altLang="ko-KR" dirty="0" smtClean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9339153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19050"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 w="12700">
          <a:solidFill>
            <a:schemeClr val="tx1"/>
          </a:solidFill>
          <a:tailEnd type="arrow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70</TotalTime>
  <Words>138</Words>
  <Application>Microsoft Office PowerPoint</Application>
  <PresentationFormat>A4 용지(210x297mm)</PresentationFormat>
  <Paragraphs>27</Paragraphs>
  <Slides>7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8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>kis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지혜</dc:creator>
  <cp:lastModifiedBy>CLee</cp:lastModifiedBy>
  <cp:revision>268</cp:revision>
  <cp:lastPrinted>2013-11-07T11:22:44Z</cp:lastPrinted>
  <dcterms:created xsi:type="dcterms:W3CDTF">2011-04-20T01:16:28Z</dcterms:created>
  <dcterms:modified xsi:type="dcterms:W3CDTF">2015-01-21T08:55:17Z</dcterms:modified>
</cp:coreProperties>
</file>